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630D6F-53A6-42C9-98A3-08C790732C1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95D8661-B5DF-4EDF-9C2D-07D9D46D96C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B5F039-EB29-4217-B86A-9B8E8A8BBA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A204F-D78A-4095-BC4B-E1E92EB01193}" type="datetimeFigureOut">
              <a:rPr lang="en-US" smtClean="0"/>
              <a:t>1/24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6A5CF7-EE5B-4911-B13B-4644AF30D6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768129-DCC6-4653-8D2B-E63A621472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DE9E41-E72E-4E2E-9F2E-467A1EFEC3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79606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519C49-449F-4C7D-8DEB-AE8C6C64F0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414BB8C-F8E9-4D4C-8CB7-3A276B33C4E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DCB211-7EBD-4DD2-8E56-A5B7D3FECD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A204F-D78A-4095-BC4B-E1E92EB01193}" type="datetimeFigureOut">
              <a:rPr lang="en-US" smtClean="0"/>
              <a:t>1/24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6CC572-B7AE-44E0-B41D-42DDA385C5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A3C222-33E1-4DB8-A95F-5A89C92192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DE9E41-E72E-4E2E-9F2E-467A1EFEC3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51478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B771AC5-2A1D-424E-8174-D9898D04663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C513F2C-BC60-40DD-A0DA-90D6B2E5285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AAF7FD-C908-4932-9028-8CB9639884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A204F-D78A-4095-BC4B-E1E92EB01193}" type="datetimeFigureOut">
              <a:rPr lang="en-US" smtClean="0"/>
              <a:t>1/24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9EC153-887C-4030-B0DE-2204B84209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721400-1C9B-4C93-9DAD-6798ED17CE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DE9E41-E72E-4E2E-9F2E-467A1EFEC3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57417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E83450-7E55-4DD8-A14C-7D8FBC91A3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9CB15BC-A51C-40E7-A718-95C6FB7747C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3750E6-79E5-482F-AFF5-5D105A768A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A204F-D78A-4095-BC4B-E1E92EB01193}" type="datetimeFigureOut">
              <a:rPr lang="en-US" smtClean="0"/>
              <a:t>1/24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A23750-7F0D-406A-AE7D-105D0B0200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BD64CE-1227-4667-A10E-9D5DBF840B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DE9E41-E72E-4E2E-9F2E-467A1EFEC3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87084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2AE96C-6840-4670-A677-7C2FC27682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85C74BF-99C8-48C9-B71A-58ED18A6B3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8FEA46-A246-4DA6-8400-819EC382F0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A204F-D78A-4095-BC4B-E1E92EB01193}" type="datetimeFigureOut">
              <a:rPr lang="en-US" smtClean="0"/>
              <a:t>1/24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B25D72-517D-403E-B7A0-F8CFA8A008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38372C-7396-4A98-A916-E9B16785C1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DE9E41-E72E-4E2E-9F2E-467A1EFEC3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97607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5121CC-3919-473A-AC43-CE4FAA5C33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6086F46-ACB2-40A5-8BB6-0A668D24259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ED15D5A-F15D-4BF6-AEF2-9FAFA922E52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DC93DC2-B115-478A-A05A-A96567CA66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A204F-D78A-4095-BC4B-E1E92EB01193}" type="datetimeFigureOut">
              <a:rPr lang="en-US" smtClean="0"/>
              <a:t>1/24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209EF90-59A8-4563-A961-6287E2435C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903F55-C8AB-47C3-B45C-A7D39D768E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DE9E41-E72E-4E2E-9F2E-467A1EFEC3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85576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281DFC-3031-4BD2-83CA-62CF8885A4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9D4A399-C339-4AFD-803C-2F74C5AEF5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A1513D8-E06A-4EB1-8498-DD855653C4D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27F927D-54A5-47FB-A5DD-347FB981592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E6019EF-54E5-4AB8-A052-00470970F66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DAB58FE-EF80-4D1C-9F0E-E37327D590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A204F-D78A-4095-BC4B-E1E92EB01193}" type="datetimeFigureOut">
              <a:rPr lang="en-US" smtClean="0"/>
              <a:t>1/24/2018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E1ADE4C-2264-4038-A58C-9915E403FC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93B5809-9D9D-400C-A8D9-9FF9CB0A4B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DE9E41-E72E-4E2E-9F2E-467A1EFEC3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92839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788F48-0BD1-4815-8BA4-E6D5B530E0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598BE7B-3954-44F5-9182-2886AE0B12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A204F-D78A-4095-BC4B-E1E92EB01193}" type="datetimeFigureOut">
              <a:rPr lang="en-US" smtClean="0"/>
              <a:t>1/24/2018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05C45B0-5C8A-4428-8E5C-D2CB3E5D28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9BE1DCA-3196-4F69-929F-0991C4CDB1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DE9E41-E72E-4E2E-9F2E-467A1EFEC3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34154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999737A-D31D-405A-893D-CC09771F1B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A204F-D78A-4095-BC4B-E1E92EB01193}" type="datetimeFigureOut">
              <a:rPr lang="en-US" smtClean="0"/>
              <a:t>1/24/2018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98D4A9B-6676-4F11-A6A1-D256547C18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4ACE7EF-8DA4-415B-B789-60D3E95CA4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DE9E41-E72E-4E2E-9F2E-467A1EFEC3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72797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842661-40B2-441D-8D6D-307A7FF868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1B1C1C-DFF1-4F88-A16B-12E7EDEBCF7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E7F284D-C895-4638-B414-19EA8488BBB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E68DAE-DB59-4767-B7A7-76A3721320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A204F-D78A-4095-BC4B-E1E92EB01193}" type="datetimeFigureOut">
              <a:rPr lang="en-US" smtClean="0"/>
              <a:t>1/24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F50BA8-2739-466A-A86F-FF22730191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A53C7C7-2EB4-4014-BDFA-1F86B63D06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DE9E41-E72E-4E2E-9F2E-467A1EFEC3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2104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0CDF19-2FF1-419E-83FD-82F5B7CEE8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11D309D-4406-4214-82EB-E8BF38B5562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4F4E6F6-06EB-4C9C-ACB9-19364540A1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D734DD-3BCC-490D-8842-F5333AD665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A204F-D78A-4095-BC4B-E1E92EB01193}" type="datetimeFigureOut">
              <a:rPr lang="en-US" smtClean="0"/>
              <a:t>1/24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A3DFE7A-4212-499F-8668-85E96A3607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8E7D70D-4255-4730-B562-31E344ADD9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DE9E41-E72E-4E2E-9F2E-467A1EFEC3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12623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AB0A19E-B9C0-44AC-8A27-27DBFB79B4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AE94520-04DD-4F49-9941-6399C11420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CCD4F0-DCB5-4DF9-B3C5-FBCC333E1DA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2A204F-D78A-4095-BC4B-E1E92EB01193}" type="datetimeFigureOut">
              <a:rPr lang="en-US" smtClean="0"/>
              <a:t>1/24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0586D3-CA68-49BA-AE65-7159A390E8D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8395C0-55D6-4D57-9259-8420BCE2BC0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DE9E41-E72E-4E2E-9F2E-467A1EFEC3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07613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CBFD6D1-DE58-4EC0-B802-0751797BCA0D}"/>
              </a:ext>
            </a:extLst>
          </p:cNvPr>
          <p:cNvSpPr txBox="1"/>
          <p:nvPr/>
        </p:nvSpPr>
        <p:spPr>
          <a:xfrm>
            <a:off x="3624560" y="493179"/>
            <a:ext cx="2305696" cy="340519"/>
          </a:xfrm>
          <a:prstGeom prst="roundRect">
            <a:avLst/>
          </a:prstGeom>
          <a:ln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Dry moringa leaves powder</a:t>
            </a:r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DD178639-3C5B-43FC-BB5E-D6FC64DF118F}"/>
              </a:ext>
            </a:extLst>
          </p:cNvPr>
          <p:cNvCxnSpPr>
            <a:cxnSpLocks/>
            <a:stCxn id="4" idx="2"/>
          </p:cNvCxnSpPr>
          <p:nvPr/>
        </p:nvCxnSpPr>
        <p:spPr>
          <a:xfrm>
            <a:off x="4777408" y="833698"/>
            <a:ext cx="0" cy="82282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D983E4DA-A58C-45B1-ACF2-4EF4D5D60461}"/>
              </a:ext>
            </a:extLst>
          </p:cNvPr>
          <p:cNvSpPr txBox="1"/>
          <p:nvPr/>
        </p:nvSpPr>
        <p:spPr>
          <a:xfrm>
            <a:off x="4780718" y="976304"/>
            <a:ext cx="25557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Extraction using hexane (Polarity 0.1) 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EAB698F-A00F-4C59-BC25-6FADE4D382F4}"/>
              </a:ext>
            </a:extLst>
          </p:cNvPr>
          <p:cNvSpPr txBox="1"/>
          <p:nvPr/>
        </p:nvSpPr>
        <p:spPr>
          <a:xfrm>
            <a:off x="3949305" y="1662768"/>
            <a:ext cx="1613069" cy="306467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lang="en-US" sz="1200" dirty="0"/>
              <a:t>Remaining Plant tissue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C6D2B197-079F-445C-9A29-0E47DB6A7351}"/>
              </a:ext>
            </a:extLst>
          </p:cNvPr>
          <p:cNvCxnSpPr>
            <a:cxnSpLocks/>
          </p:cNvCxnSpPr>
          <p:nvPr/>
        </p:nvCxnSpPr>
        <p:spPr>
          <a:xfrm>
            <a:off x="4777408" y="1417982"/>
            <a:ext cx="186193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A50CDF2D-F8B6-4DEE-B4DB-F3324377D80D}"/>
              </a:ext>
            </a:extLst>
          </p:cNvPr>
          <p:cNvCxnSpPr>
            <a:cxnSpLocks/>
          </p:cNvCxnSpPr>
          <p:nvPr/>
        </p:nvCxnSpPr>
        <p:spPr>
          <a:xfrm>
            <a:off x="6639339" y="1417982"/>
            <a:ext cx="0" cy="23854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C4C8111F-BA50-4FA7-B7DF-3DFFFE5786A5}"/>
              </a:ext>
            </a:extLst>
          </p:cNvPr>
          <p:cNvSpPr txBox="1"/>
          <p:nvPr/>
        </p:nvSpPr>
        <p:spPr>
          <a:xfrm>
            <a:off x="6165459" y="1662269"/>
            <a:ext cx="1859081" cy="306467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lang="en-US" sz="1200" dirty="0"/>
              <a:t>Hexane (H) extract residue</a:t>
            </a:r>
          </a:p>
        </p:txBody>
      </p: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DD8F047A-084F-44E3-82D0-529C3CA4A677}"/>
              </a:ext>
            </a:extLst>
          </p:cNvPr>
          <p:cNvCxnSpPr>
            <a:cxnSpLocks/>
          </p:cNvCxnSpPr>
          <p:nvPr/>
        </p:nvCxnSpPr>
        <p:spPr>
          <a:xfrm>
            <a:off x="4777408" y="1969234"/>
            <a:ext cx="0" cy="82282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5E4133B5-D6CC-4062-934A-2E7A8795E886}"/>
              </a:ext>
            </a:extLst>
          </p:cNvPr>
          <p:cNvSpPr txBox="1"/>
          <p:nvPr/>
        </p:nvSpPr>
        <p:spPr>
          <a:xfrm>
            <a:off x="4787632" y="2098588"/>
            <a:ext cx="28864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Extraction using diethyl ether (Polarity 2.8) 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2D214594-A872-43B5-9425-EC89785F5FEE}"/>
              </a:ext>
            </a:extLst>
          </p:cNvPr>
          <p:cNvSpPr txBox="1"/>
          <p:nvPr/>
        </p:nvSpPr>
        <p:spPr>
          <a:xfrm>
            <a:off x="3949305" y="2798304"/>
            <a:ext cx="1613069" cy="306467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lang="en-US" sz="1200" dirty="0"/>
              <a:t>Remaining Plant tissue</a:t>
            </a:r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D7930BBC-D8A0-4258-813E-57BE275BDF6E}"/>
              </a:ext>
            </a:extLst>
          </p:cNvPr>
          <p:cNvCxnSpPr>
            <a:cxnSpLocks/>
          </p:cNvCxnSpPr>
          <p:nvPr/>
        </p:nvCxnSpPr>
        <p:spPr>
          <a:xfrm>
            <a:off x="4777408" y="2553518"/>
            <a:ext cx="186193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7661E8FC-DE01-4DE2-9A77-4851345F329F}"/>
              </a:ext>
            </a:extLst>
          </p:cNvPr>
          <p:cNvSpPr txBox="1"/>
          <p:nvPr/>
        </p:nvSpPr>
        <p:spPr>
          <a:xfrm>
            <a:off x="6165459" y="2796022"/>
            <a:ext cx="2358098" cy="306467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lang="en-US" sz="1200" dirty="0"/>
              <a:t>Diethyl ether (DEE) extract residue</a:t>
            </a:r>
          </a:p>
        </p:txBody>
      </p:sp>
      <p:cxnSp>
        <p:nvCxnSpPr>
          <p:cNvPr id="47" name="Straight Arrow Connector 46">
            <a:extLst>
              <a:ext uri="{FF2B5EF4-FFF2-40B4-BE49-F238E27FC236}">
                <a16:creationId xmlns:a16="http://schemas.microsoft.com/office/drawing/2014/main" id="{9099528E-D9E2-47D3-AEA1-42EC957FDD3D}"/>
              </a:ext>
            </a:extLst>
          </p:cNvPr>
          <p:cNvCxnSpPr>
            <a:cxnSpLocks/>
          </p:cNvCxnSpPr>
          <p:nvPr/>
        </p:nvCxnSpPr>
        <p:spPr>
          <a:xfrm>
            <a:off x="4777408" y="3104769"/>
            <a:ext cx="0" cy="82282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29623E47-7ED3-49DF-B3B5-D57AA640F2F0}"/>
              </a:ext>
            </a:extLst>
          </p:cNvPr>
          <p:cNvSpPr txBox="1"/>
          <p:nvPr/>
        </p:nvSpPr>
        <p:spPr>
          <a:xfrm>
            <a:off x="4784371" y="3261470"/>
            <a:ext cx="28950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Extraction using ethyl acetate (Polarity 4.4) 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6BF78D25-9D1B-4626-8659-69A59C7D3961}"/>
              </a:ext>
            </a:extLst>
          </p:cNvPr>
          <p:cNvSpPr txBox="1"/>
          <p:nvPr/>
        </p:nvSpPr>
        <p:spPr>
          <a:xfrm>
            <a:off x="3949305" y="3933839"/>
            <a:ext cx="1613069" cy="306467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lang="en-US" sz="1200" dirty="0"/>
              <a:t>Remaining Plant tissue</a:t>
            </a: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D1E3AD5B-D62F-4A5C-839B-8BE39075814D}"/>
              </a:ext>
            </a:extLst>
          </p:cNvPr>
          <p:cNvCxnSpPr>
            <a:cxnSpLocks/>
          </p:cNvCxnSpPr>
          <p:nvPr/>
        </p:nvCxnSpPr>
        <p:spPr>
          <a:xfrm>
            <a:off x="4777408" y="3689053"/>
            <a:ext cx="186193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5CF1D68D-5A55-481B-90A3-A3477F9232E3}"/>
              </a:ext>
            </a:extLst>
          </p:cNvPr>
          <p:cNvSpPr txBox="1"/>
          <p:nvPr/>
        </p:nvSpPr>
        <p:spPr>
          <a:xfrm>
            <a:off x="6165459" y="3933339"/>
            <a:ext cx="2269535" cy="306467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lang="en-US" sz="1200" dirty="0"/>
              <a:t>Ethyl acetate (EA) extract residue</a:t>
            </a:r>
          </a:p>
        </p:txBody>
      </p: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CE968280-67D1-49E2-8F57-F3E47F742E9C}"/>
              </a:ext>
            </a:extLst>
          </p:cNvPr>
          <p:cNvCxnSpPr>
            <a:cxnSpLocks/>
          </p:cNvCxnSpPr>
          <p:nvPr/>
        </p:nvCxnSpPr>
        <p:spPr>
          <a:xfrm>
            <a:off x="4777408" y="4240304"/>
            <a:ext cx="0" cy="82282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id="{E87B732A-0A6E-41D1-AABF-9920E625C61E}"/>
              </a:ext>
            </a:extLst>
          </p:cNvPr>
          <p:cNvSpPr txBox="1"/>
          <p:nvPr/>
        </p:nvSpPr>
        <p:spPr>
          <a:xfrm>
            <a:off x="4779140" y="4369658"/>
            <a:ext cx="26914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Extraction using methanol (Polarity 5.1) 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7C311C0B-9FE0-4643-8610-7FD3D3634BAB}"/>
              </a:ext>
            </a:extLst>
          </p:cNvPr>
          <p:cNvSpPr txBox="1"/>
          <p:nvPr/>
        </p:nvSpPr>
        <p:spPr>
          <a:xfrm>
            <a:off x="3949305" y="5069374"/>
            <a:ext cx="1613069" cy="306467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lang="en-US" sz="1200" dirty="0"/>
              <a:t>Remaining Plant tissue</a:t>
            </a:r>
          </a:p>
        </p:txBody>
      </p: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F4043478-3BD9-4045-86CF-E9A6A68BB76B}"/>
              </a:ext>
            </a:extLst>
          </p:cNvPr>
          <p:cNvCxnSpPr>
            <a:cxnSpLocks/>
          </p:cNvCxnSpPr>
          <p:nvPr/>
        </p:nvCxnSpPr>
        <p:spPr>
          <a:xfrm>
            <a:off x="4777408" y="4824588"/>
            <a:ext cx="186193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9E378281-366E-49F4-8151-CFAC37A913A1}"/>
              </a:ext>
            </a:extLst>
          </p:cNvPr>
          <p:cNvSpPr txBox="1"/>
          <p:nvPr/>
        </p:nvSpPr>
        <p:spPr>
          <a:xfrm>
            <a:off x="6165459" y="5069371"/>
            <a:ext cx="2318154" cy="306467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lang="en-US" sz="1200" dirty="0"/>
              <a:t>Methanol (MeOH) extract residue</a:t>
            </a:r>
          </a:p>
        </p:txBody>
      </p: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BF2DE947-D664-422A-941A-732AAE67B269}"/>
              </a:ext>
            </a:extLst>
          </p:cNvPr>
          <p:cNvCxnSpPr>
            <a:cxnSpLocks/>
          </p:cNvCxnSpPr>
          <p:nvPr/>
        </p:nvCxnSpPr>
        <p:spPr>
          <a:xfrm>
            <a:off x="4777408" y="5375838"/>
            <a:ext cx="0" cy="82282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id="{50D02927-67DC-40F3-A450-54AE49C208C7}"/>
              </a:ext>
            </a:extLst>
          </p:cNvPr>
          <p:cNvSpPr txBox="1"/>
          <p:nvPr/>
        </p:nvSpPr>
        <p:spPr>
          <a:xfrm>
            <a:off x="4789231" y="5505192"/>
            <a:ext cx="2803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Extraction using acetonitrile (Polarity 5.8) 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9A558304-87D5-4592-9DEF-E7B6EE879DC6}"/>
              </a:ext>
            </a:extLst>
          </p:cNvPr>
          <p:cNvSpPr txBox="1"/>
          <p:nvPr/>
        </p:nvSpPr>
        <p:spPr>
          <a:xfrm>
            <a:off x="3949305" y="6204908"/>
            <a:ext cx="1613069" cy="306467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lang="en-US" sz="1200" dirty="0"/>
              <a:t>Remaining Plant tissue</a:t>
            </a:r>
          </a:p>
        </p:txBody>
      </p: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DA12D981-1373-466E-8409-919A9604AC75}"/>
              </a:ext>
            </a:extLst>
          </p:cNvPr>
          <p:cNvCxnSpPr>
            <a:cxnSpLocks/>
          </p:cNvCxnSpPr>
          <p:nvPr/>
        </p:nvCxnSpPr>
        <p:spPr>
          <a:xfrm>
            <a:off x="4777408" y="5960122"/>
            <a:ext cx="186193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id="{F016858F-0043-4D99-A639-EB1CFE55A40E}"/>
              </a:ext>
            </a:extLst>
          </p:cNvPr>
          <p:cNvSpPr txBox="1"/>
          <p:nvPr/>
        </p:nvSpPr>
        <p:spPr>
          <a:xfrm>
            <a:off x="6165459" y="6198662"/>
            <a:ext cx="2300933" cy="306467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lang="en-US" sz="1200" dirty="0"/>
              <a:t>Acetonitrile (ACN) extract residue</a:t>
            </a:r>
          </a:p>
        </p:txBody>
      </p:sp>
      <p:cxnSp>
        <p:nvCxnSpPr>
          <p:cNvPr id="62" name="Straight Arrow Connector 61">
            <a:extLst>
              <a:ext uri="{FF2B5EF4-FFF2-40B4-BE49-F238E27FC236}">
                <a16:creationId xmlns:a16="http://schemas.microsoft.com/office/drawing/2014/main" id="{7C862906-F92E-4844-A5C2-085A2908A939}"/>
              </a:ext>
            </a:extLst>
          </p:cNvPr>
          <p:cNvCxnSpPr>
            <a:cxnSpLocks/>
          </p:cNvCxnSpPr>
          <p:nvPr/>
        </p:nvCxnSpPr>
        <p:spPr>
          <a:xfrm>
            <a:off x="6639339" y="2553518"/>
            <a:ext cx="0" cy="23854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ADBB2304-74C9-4750-A4FF-83DCF9F7F090}"/>
              </a:ext>
            </a:extLst>
          </p:cNvPr>
          <p:cNvCxnSpPr>
            <a:cxnSpLocks/>
          </p:cNvCxnSpPr>
          <p:nvPr/>
        </p:nvCxnSpPr>
        <p:spPr>
          <a:xfrm>
            <a:off x="6639339" y="3689053"/>
            <a:ext cx="0" cy="23854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Arrow Connector 63">
            <a:extLst>
              <a:ext uri="{FF2B5EF4-FFF2-40B4-BE49-F238E27FC236}">
                <a16:creationId xmlns:a16="http://schemas.microsoft.com/office/drawing/2014/main" id="{66DC326F-4E40-461D-A2C9-D0E5D5F18708}"/>
              </a:ext>
            </a:extLst>
          </p:cNvPr>
          <p:cNvCxnSpPr>
            <a:cxnSpLocks/>
          </p:cNvCxnSpPr>
          <p:nvPr/>
        </p:nvCxnSpPr>
        <p:spPr>
          <a:xfrm>
            <a:off x="6639339" y="4824588"/>
            <a:ext cx="0" cy="23854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Arrow Connector 65">
            <a:extLst>
              <a:ext uri="{FF2B5EF4-FFF2-40B4-BE49-F238E27FC236}">
                <a16:creationId xmlns:a16="http://schemas.microsoft.com/office/drawing/2014/main" id="{EE7AA39D-3F4B-417E-A9C2-F80E656C5104}"/>
              </a:ext>
            </a:extLst>
          </p:cNvPr>
          <p:cNvCxnSpPr>
            <a:cxnSpLocks/>
          </p:cNvCxnSpPr>
          <p:nvPr/>
        </p:nvCxnSpPr>
        <p:spPr>
          <a:xfrm>
            <a:off x="6645965" y="5960122"/>
            <a:ext cx="0" cy="23854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278466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74</TotalTime>
  <Words>88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HAMED SAMY</dc:creator>
  <cp:lastModifiedBy>MOHAMED SAMY</cp:lastModifiedBy>
  <cp:revision>8</cp:revision>
  <dcterms:created xsi:type="dcterms:W3CDTF">2018-01-24T16:38:29Z</dcterms:created>
  <dcterms:modified xsi:type="dcterms:W3CDTF">2018-01-25T17:12:45Z</dcterms:modified>
</cp:coreProperties>
</file>